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43" d="100"/>
          <a:sy n="143" d="100"/>
        </p:scale>
        <p:origin x="-1744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662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621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292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036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845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871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699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390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506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446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850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752EC-A6B5-5149-8194-B328E83574B9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2909B-4F6C-3041-9836-15219846C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947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5623975"/>
              </p:ext>
            </p:extLst>
          </p:nvPr>
        </p:nvGraphicFramePr>
        <p:xfrm>
          <a:off x="127000" y="1349374"/>
          <a:ext cx="6604000" cy="2712529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23875"/>
                <a:gridCol w="649605"/>
                <a:gridCol w="772160"/>
                <a:gridCol w="751840"/>
                <a:gridCol w="792480"/>
                <a:gridCol w="792480"/>
                <a:gridCol w="843280"/>
                <a:gridCol w="762000"/>
                <a:gridCol w="716280"/>
              </a:tblGrid>
              <a:tr h="375920"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</a:rPr>
                        <a:t>  Le-SC-ASC</a:t>
                      </a:r>
                      <a:endParaRPr lang="en-US" sz="800" b="0" dirty="0" smtClean="0">
                        <a:solidFill>
                          <a:schemeClr val="tx1"/>
                        </a:solidFill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</a:rPr>
                        <a:t>%±SEM         MFI±SEM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</a:rPr>
                        <a:t>    Le-V-ASC</a:t>
                      </a:r>
                      <a:endParaRPr lang="en-US" sz="800" b="0" dirty="0" smtClean="0">
                        <a:solidFill>
                          <a:schemeClr val="tx1"/>
                        </a:solidFill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</a:rPr>
                        <a:t> %±SEM     MFI±SEM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</a:rPr>
                        <a:t>Ob-SC-ASC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</a:rPr>
                        <a:t> %±SEM              MFI±SEM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</a:rPr>
                        <a:t>Ob-V-ASC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</a:rPr>
                        <a:t>   %±SEM                 MFI±SEM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661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2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ts val="8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96.7±3</a:t>
                      </a:r>
                    </a:p>
                  </a:txBody>
                  <a:tcPr marL="12700" marR="12700" marT="1270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840"/>
                        </a:lnSpc>
                      </a:pP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7271±732</a:t>
                      </a:r>
                    </a:p>
                  </a:txBody>
                  <a:tcPr marL="12700" marR="12700" marT="1270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ts val="84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99.8±0.1</a:t>
                      </a:r>
                      <a:endParaRPr lang="en-US" sz="800" dirty="0"/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840"/>
                        </a:lnSpc>
                      </a:pP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2201±1658</a:t>
                      </a:r>
                    </a:p>
                  </a:txBody>
                  <a:tcPr marL="12700" marR="12700" marT="1270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840"/>
                        </a:lnSpc>
                      </a:pP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99±0.3</a:t>
                      </a:r>
                    </a:p>
                  </a:txBody>
                  <a:tcPr marL="12700" marR="12700" marT="1270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840"/>
                        </a:lnSpc>
                      </a:pP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5470±245</a:t>
                      </a:r>
                    </a:p>
                  </a:txBody>
                  <a:tcPr marL="12700" marR="12700" marT="1270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840"/>
                        </a:lnSpc>
                      </a:pP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99.5±0.1</a:t>
                      </a:r>
                    </a:p>
                  </a:txBody>
                  <a:tcPr marL="12700" marR="12700" marT="1270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840"/>
                        </a:lnSpc>
                      </a:pP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9618.5±225.5</a:t>
                      </a:r>
                    </a:p>
                  </a:txBody>
                  <a:tcPr marL="12700" marR="12700" marT="1270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30304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34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4.1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±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645.6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284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5±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375.8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57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1±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306.8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2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7.1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6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482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2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8661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31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6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227.483.8</a:t>
                      </a:r>
                      <a:endParaRPr lang="en-US" sz="8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4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163.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73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31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181.1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4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131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±30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8661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11b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4.4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3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491.1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37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6.2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±3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685.4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37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1.5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190.2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43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2.0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324.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77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8661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45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4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564.5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21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595.2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290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4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399.7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40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6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632.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5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8661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73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6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474.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89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8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517.7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60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35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505.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60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0.1±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335.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89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8661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90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77.4±6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21144.5±3576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92.8±1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2084.5±172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98.3±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8527.5±217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41.3±</a:t>
                      </a:r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0.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5*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797±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8*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86615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D105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55.7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9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2646.7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877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70.7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16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3303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577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55.6±2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1550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717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20.1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9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effectLst/>
                          <a:latin typeface="Arial"/>
                        </a:rPr>
                        <a:t>1115.7±</a:t>
                      </a:r>
                      <a:r>
                        <a:rPr lang="en-US" sz="800" b="0" i="0" u="none" strike="noStrike" dirty="0">
                          <a:effectLst/>
                          <a:latin typeface="Arial"/>
                        </a:rPr>
                        <a:t>768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42813" y="951481"/>
            <a:ext cx="53912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1 Table Statistical results of ASC surface marker expression detected by flow cytometer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585306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62</Words>
  <Application>Microsoft Macintosh PowerPoint</Application>
  <PresentationFormat>On-screen Show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DA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 Zhang</dc:creator>
  <cp:lastModifiedBy>Yan Zhang</cp:lastModifiedBy>
  <cp:revision>10</cp:revision>
  <dcterms:created xsi:type="dcterms:W3CDTF">2015-02-16T00:07:36Z</dcterms:created>
  <dcterms:modified xsi:type="dcterms:W3CDTF">2015-08-09T07:13:20Z</dcterms:modified>
</cp:coreProperties>
</file>